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90" d="100"/>
          <a:sy n="90" d="100"/>
        </p:scale>
        <p:origin x="4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6632A16-B22A-43EC-861D-CE01F6207D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5EE3114B-7091-444B-BA73-006D63CA6A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CB8C387-0B10-4955-AFE8-66880C045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20DF10D-83EA-47A2-BFBF-A9B81B130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E63FE06-ED10-4E46-B4CB-D58611CA6A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4143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A90A5F3-87E2-45CD-8C81-7C5DF36331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4E477DB-B2E1-47E0-9174-1E3D6B6C7B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FA068DD-60C7-4FC3-BC1D-B4812AEBFB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E3EB020-44B0-4B6E-837A-BECA51986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F7D0D90-9002-4A3C-BB30-28B01225E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78260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9E4572A-16B6-45E5-B210-E59ADD13E7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F620D44-4441-4F1B-B649-3C9426ABA6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89DF712-2DEF-4F25-9CFA-5E7BD0B7B0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50FCDCA-6414-4CB8-9942-9A8205F0FF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483A668-DF14-4DBE-917E-40AF5D4F5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8981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8DA8332-E1B2-41DF-AE11-1FC668654C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92B8B74-B12C-46B7-982D-717480CA2D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E7AF879-1527-49C2-AA55-97CB0BB72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7F41C27-A489-417B-8082-368AC5BBA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91F17D7-4156-4E2D-A233-D98D14EDA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5947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03AEA6E-9BF0-4EB5-96D5-1C4591E239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2981D8D-39A7-49B6-B9CA-5AC31E161F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0DFAFE-57D9-4110-95B7-7C3248A68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B2385B1-282C-457D-AFAB-6947C6B6C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5119557-A9CA-47F8-AAA2-3558A9EC0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6718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AD66E4A-30D3-4158-8A54-C7A3832210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DC4C38C-4AD3-44E4-9224-F27E664D00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735A049-95D2-401F-BB3E-0F0CE8C78D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1E7D309-9A0B-49D0-9B9A-B3B8C29BA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A2C39A7-7EC7-432F-A66B-9BF303551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20DC049-AE55-4B9F-B904-DC714950A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9247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515353F-C767-4EAE-A029-29BE41A721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F87C092-586B-49E2-B393-4B9C110AD9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2C4DFFF-32BF-4385-9DA8-7430D91D7B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2B1EF4C7-28E2-4274-8FF9-AF3046EEF32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EBCB5DC3-6138-45E6-A9A9-6D40DAC6A8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E7C9CD1-317D-480E-8D2A-900A09DDC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6C9D0C68-4524-44F3-A5E1-A169A4CFB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3BB4FB0-1C8E-47C2-9775-16B59C669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8185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3B1E012-7DC0-423E-8793-C16590D9B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920BCC5-96DC-4543-A1AB-79035EB5B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92BCFD66-152A-4FF7-92E2-7A204E4F9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3CF6F65-EA69-49D7-B984-94842FBFB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5554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562B931-91E2-4323-B7DD-53C3FB830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E8FDA4C-7BB6-4A74-BC04-6A578C732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D16C17B-F3FF-4369-AFFA-AA63A2D9B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2128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D88EBA0-ED91-4A40-96BC-464C9CAE63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779B0FF-7A17-43D7-9FDD-C0C7DC57B8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7B9E934-312B-478F-B243-CC2C264BB7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6A7B8DE-17D7-47EE-B0B9-184AD59C1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93D7F45-620D-4618-8070-56800402E4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C437440-9D64-4592-B5C6-2BD3363401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9977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6CC293E-C513-41FD-8ADF-3384C9244A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C00D486-9D27-47D1-8792-48D1B3BCE5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2DC4DEE-54C0-49EE-B91F-4DEA358FB4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5253233-EA49-429E-96B9-E8246E266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1251B5-1A72-4A90-B8DC-7D93383E7D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2D9992D-268D-490E-B819-577189F33B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79931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569DC9A-F220-4890-96B4-C4B88F2B44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50DB92F-8D4B-40E8-AC89-68B4B4B4FA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3B36965-90AA-4D4B-98BF-7AB48841AC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4D17A-4C82-4884-B1AF-41D0BB4DB96F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2536DF0-91F3-449D-8720-2D22C43887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CAD81CB-C40F-4EDF-985B-609BA6ED25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DBDF00-A53A-40D0-8474-438D8358526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2023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22D318E2-4830-4941-AFCB-63FD324FAF64}"/>
              </a:ext>
            </a:extLst>
          </p:cNvPr>
          <p:cNvGrpSpPr/>
          <p:nvPr/>
        </p:nvGrpSpPr>
        <p:grpSpPr>
          <a:xfrm>
            <a:off x="159504" y="247680"/>
            <a:ext cx="11800043" cy="6037150"/>
            <a:chOff x="54404" y="247680"/>
            <a:chExt cx="11800043" cy="6037150"/>
          </a:xfrm>
        </p:grpSpPr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CA026455-A9BB-42DE-AD65-8D304DD61675}"/>
                </a:ext>
              </a:extLst>
            </p:cNvPr>
            <p:cNvSpPr txBox="1"/>
            <p:nvPr/>
          </p:nvSpPr>
          <p:spPr>
            <a:xfrm>
              <a:off x="303658" y="247680"/>
              <a:ext cx="20123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Un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endParaRPr lang="fr-FR" sz="1400" b="1" dirty="0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3E095E98-FB10-4632-ABAC-8D5D7E24BB14}"/>
                </a:ext>
              </a:extLst>
            </p:cNvPr>
            <p:cNvSpPr txBox="1"/>
            <p:nvPr/>
          </p:nvSpPr>
          <p:spPr>
            <a:xfrm>
              <a:off x="9360942" y="2607813"/>
              <a:ext cx="21583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labeled</a:t>
              </a:r>
              <a:r>
                <a:rPr lang="fr-FR" sz="1200" dirty="0"/>
                <a:t> B lymphocytes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98F442FB-E16F-48C2-8300-436C8FCB20B1}"/>
                </a:ext>
              </a:extLst>
            </p:cNvPr>
            <p:cNvSpPr txBox="1"/>
            <p:nvPr/>
          </p:nvSpPr>
          <p:spPr>
            <a:xfrm>
              <a:off x="131646" y="2279146"/>
              <a:ext cx="25378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</a:t>
              </a:r>
              <a:r>
                <a:rPr lang="el-GR" sz="1400" b="1" dirty="0"/>
                <a:t>3Δ</a:t>
              </a:r>
              <a:r>
                <a:rPr lang="fr-FR" sz="1400" b="1" dirty="0"/>
                <a:t> 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B679AC25-A109-4D68-AE69-D05E667E6BF3}"/>
                </a:ext>
              </a:extLst>
            </p:cNvPr>
            <p:cNvSpPr txBox="1"/>
            <p:nvPr/>
          </p:nvSpPr>
          <p:spPr>
            <a:xfrm>
              <a:off x="9370951" y="3797785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01D3C4F2-309A-4C18-BF71-65F2682EA3EF}"/>
                </a:ext>
              </a:extLst>
            </p:cNvPr>
            <p:cNvSpPr txBox="1"/>
            <p:nvPr/>
          </p:nvSpPr>
          <p:spPr>
            <a:xfrm>
              <a:off x="54404" y="4483712"/>
              <a:ext cx="27120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</a:t>
              </a:r>
              <a:r>
                <a:rPr lang="el-GR" sz="1400" b="1" dirty="0"/>
                <a:t>Δ</a:t>
              </a:r>
              <a:r>
                <a:rPr lang="fr-FR" sz="1400" b="1" i="1" dirty="0" err="1"/>
                <a:t>invA</a:t>
              </a:r>
              <a:r>
                <a:rPr lang="fr-FR" sz="1400" b="1" dirty="0"/>
                <a:t>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86EFF6E0-B7BE-46C0-9302-C50A21ADD3AF}"/>
                </a:ext>
              </a:extLst>
            </p:cNvPr>
            <p:cNvSpPr txBox="1"/>
            <p:nvPr/>
          </p:nvSpPr>
          <p:spPr>
            <a:xfrm>
              <a:off x="9370951" y="5994575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9238B342-6126-4A1A-9010-75B7981EF156}"/>
                </a:ext>
              </a:extLst>
            </p:cNvPr>
            <p:cNvSpPr txBox="1"/>
            <p:nvPr/>
          </p:nvSpPr>
          <p:spPr>
            <a:xfrm>
              <a:off x="1289017" y="877775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97A99491-2D1B-497C-82EA-96D163338B05}"/>
                </a:ext>
              </a:extLst>
            </p:cNvPr>
            <p:cNvSpPr txBox="1"/>
            <p:nvPr/>
          </p:nvSpPr>
          <p:spPr>
            <a:xfrm>
              <a:off x="1309845" y="3054398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BFA6729E-1564-4DE0-8970-E67A88961C76}"/>
                </a:ext>
              </a:extLst>
            </p:cNvPr>
            <p:cNvSpPr txBox="1"/>
            <p:nvPr/>
          </p:nvSpPr>
          <p:spPr>
            <a:xfrm>
              <a:off x="1253206" y="5301844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BD24A082-87FB-40AB-9AEA-F3A7CE6818C7}"/>
                </a:ext>
              </a:extLst>
            </p:cNvPr>
            <p:cNvSpPr txBox="1"/>
            <p:nvPr/>
          </p:nvSpPr>
          <p:spPr>
            <a:xfrm>
              <a:off x="5711985" y="481540"/>
              <a:ext cx="16526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B lymphocytes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4A201F4E-6FCB-43A9-AE3F-8A1950B5E89A}"/>
                </a:ext>
              </a:extLst>
            </p:cNvPr>
            <p:cNvSpPr txBox="1"/>
            <p:nvPr/>
          </p:nvSpPr>
          <p:spPr>
            <a:xfrm>
              <a:off x="5948814" y="6007831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0320534D-BA65-4729-A678-FC6B0FF2FCF9}"/>
                </a:ext>
              </a:extLst>
            </p:cNvPr>
            <p:cNvSpPr txBox="1"/>
            <p:nvPr/>
          </p:nvSpPr>
          <p:spPr>
            <a:xfrm>
              <a:off x="5955455" y="3822197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</p:grpSp>
      <p:sp>
        <p:nvSpPr>
          <p:cNvPr id="41" name="ZoneTexte 40">
            <a:extLst>
              <a:ext uri="{FF2B5EF4-FFF2-40B4-BE49-F238E27FC236}">
                <a16:creationId xmlns:a16="http://schemas.microsoft.com/office/drawing/2014/main" id="{767BB29B-24FB-4CE7-8123-E1A816F4AC24}"/>
              </a:ext>
            </a:extLst>
          </p:cNvPr>
          <p:cNvSpPr txBox="1"/>
          <p:nvPr/>
        </p:nvSpPr>
        <p:spPr>
          <a:xfrm>
            <a:off x="10205545" y="291263"/>
            <a:ext cx="1619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S3 </a:t>
            </a:r>
            <a:r>
              <a:rPr lang="fr-FR" b="1"/>
              <a:t>Fig</a:t>
            </a:r>
            <a:endParaRPr lang="fr-FR" b="1" dirty="0"/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4A201F29-7FB3-420C-BD4F-4C3EEAA8A5EE}"/>
              </a:ext>
            </a:extLst>
          </p:cNvPr>
          <p:cNvSpPr txBox="1"/>
          <p:nvPr/>
        </p:nvSpPr>
        <p:spPr>
          <a:xfrm>
            <a:off x="5719360" y="2653750"/>
            <a:ext cx="165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/>
              <a:t>Labeled</a:t>
            </a:r>
            <a:r>
              <a:rPr lang="fr-FR" sz="1200" dirty="0"/>
              <a:t> B lymphocytes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18A0A4DB-1F53-4750-BB66-5BE0DD18FF85}"/>
              </a:ext>
            </a:extLst>
          </p:cNvPr>
          <p:cNvSpPr txBox="1"/>
          <p:nvPr/>
        </p:nvSpPr>
        <p:spPr>
          <a:xfrm>
            <a:off x="5630240" y="4887668"/>
            <a:ext cx="165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/>
              <a:t>Labeled</a:t>
            </a:r>
            <a:r>
              <a:rPr lang="fr-FR" sz="1200" dirty="0"/>
              <a:t> B lymphocytes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6A8C3BE8-0DB0-4006-A348-EEB4244F46D7}"/>
              </a:ext>
            </a:extLst>
          </p:cNvPr>
          <p:cNvSpPr txBox="1"/>
          <p:nvPr/>
        </p:nvSpPr>
        <p:spPr>
          <a:xfrm>
            <a:off x="9466043" y="4869509"/>
            <a:ext cx="2158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/>
              <a:t>Infected</a:t>
            </a:r>
            <a:r>
              <a:rPr lang="fr-FR" sz="1200" dirty="0"/>
              <a:t> </a:t>
            </a:r>
            <a:r>
              <a:rPr lang="fr-FR" sz="1200" dirty="0" err="1"/>
              <a:t>labeled</a:t>
            </a:r>
            <a:r>
              <a:rPr lang="fr-FR" sz="1200" dirty="0"/>
              <a:t> B lymphocytes</a:t>
            </a:r>
          </a:p>
        </p:txBody>
      </p:sp>
      <p:pic>
        <p:nvPicPr>
          <p:cNvPr id="55" name="Picture 4" descr="C:\Users\trs-confocal\AppData\Local\Temp\tmp02742015567210871916.png">
            <a:extLst>
              <a:ext uri="{FF2B5EF4-FFF2-40B4-BE49-F238E27FC236}">
                <a16:creationId xmlns:a16="http://schemas.microsoft.com/office/drawing/2014/main" id="{99B6F9E8-58F1-497B-8248-43F75D08F81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2292" y="241299"/>
            <a:ext cx="1946179" cy="20378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7" descr="C:\Users\trs-confocal\AppData\Local\Temp\tmp02971984734368779307.png">
            <a:extLst>
              <a:ext uri="{FF2B5EF4-FFF2-40B4-BE49-F238E27FC236}">
                <a16:creationId xmlns:a16="http://schemas.microsoft.com/office/drawing/2014/main" id="{A8EACB95-39DD-4124-9822-44673C6B5F7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2292" y="2403294"/>
            <a:ext cx="1959133" cy="20514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7" name="Picture 10" descr="C:\Users\trs-confocal\AppData\Local\Temp\tmp01471564142038067936.png">
            <a:extLst>
              <a:ext uri="{FF2B5EF4-FFF2-40B4-BE49-F238E27FC236}">
                <a16:creationId xmlns:a16="http://schemas.microsoft.com/office/drawing/2014/main" id="{E9618CCC-A76A-4BB1-9ED3-4B9067C4F91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2293" y="4637601"/>
            <a:ext cx="1968028" cy="20607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8" name="Picture 4" descr="C:\Users\trs-confocal\AppData\Local\Temp\tmp18041644572085578497.png">
            <a:extLst>
              <a:ext uri="{FF2B5EF4-FFF2-40B4-BE49-F238E27FC236}">
                <a16:creationId xmlns:a16="http://schemas.microsoft.com/office/drawing/2014/main" id="{EC9C3E2D-92B2-4845-8324-379A09800DB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7158" y="300851"/>
            <a:ext cx="1880438" cy="19690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9" name="Picture 8" descr="C:\Users\trs-confocal\AppData\Local\Temp\tmp1732651046180561590.png">
            <a:extLst>
              <a:ext uri="{FF2B5EF4-FFF2-40B4-BE49-F238E27FC236}">
                <a16:creationId xmlns:a16="http://schemas.microsoft.com/office/drawing/2014/main" id="{E19F59FB-4E2B-4D5C-81F2-EADA4E28EA3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7159" y="2403294"/>
            <a:ext cx="1880437" cy="19690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0" name="Picture 12" descr="C:\Users\trs-confocal\AppData\Local\Temp\tmp13968228676810249318.png">
            <a:extLst>
              <a:ext uri="{FF2B5EF4-FFF2-40B4-BE49-F238E27FC236}">
                <a16:creationId xmlns:a16="http://schemas.microsoft.com/office/drawing/2014/main" id="{16F8E6A2-00FA-4771-832A-B57CE8425B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06492" y="4637601"/>
            <a:ext cx="1826907" cy="20236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349144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0</Words>
  <Application>Microsoft Office PowerPoint</Application>
  <PresentationFormat>Grand écran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ie Roche</dc:creator>
  <cp:lastModifiedBy>Sylvie Roche</cp:lastModifiedBy>
  <cp:revision>2</cp:revision>
  <dcterms:created xsi:type="dcterms:W3CDTF">2020-06-04T06:37:25Z</dcterms:created>
  <dcterms:modified xsi:type="dcterms:W3CDTF">2020-09-18T09:07:03Z</dcterms:modified>
</cp:coreProperties>
</file>